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4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3744" y="2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amon\Documents\PhD\LPS%20Stress\GO%20with%20G%20profiler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amon\Documents\PhD\LPS%20Stress\GO%20with%20G%20profiler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1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i="1"/>
              <a:t>Biological Proces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1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57372365072122866"/>
          <c:y val="0.13638802010266537"/>
          <c:w val="0.39180110991794903"/>
          <c:h val="0.67087906777283246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B2DE8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Figures!$B$7:$B$14</c:f>
              <c:strCache>
                <c:ptCount val="8"/>
                <c:pt idx="0">
                  <c:v>Anatomical structure development</c:v>
                </c:pt>
                <c:pt idx="1">
                  <c:v>Cellular response to cytokine stimulus</c:v>
                </c:pt>
                <c:pt idx="2">
                  <c:v>Reproduction</c:v>
                </c:pt>
                <c:pt idx="3">
                  <c:v>Reproductive process</c:v>
                </c:pt>
                <c:pt idx="4">
                  <c:v>Response to organic substance</c:v>
                </c:pt>
                <c:pt idx="5">
                  <c:v>Cellular response to organic substance</c:v>
                </c:pt>
                <c:pt idx="6">
                  <c:v>Cellular response to chemical stimulus</c:v>
                </c:pt>
                <c:pt idx="7">
                  <c:v>Response to cytokine</c:v>
                </c:pt>
              </c:strCache>
            </c:strRef>
          </c:cat>
          <c:val>
            <c:numRef>
              <c:f>Figures!$C$7:$C$14</c:f>
              <c:numCache>
                <c:formatCode>General</c:formatCode>
                <c:ptCount val="8"/>
                <c:pt idx="0">
                  <c:v>1.4735474028461499</c:v>
                </c:pt>
                <c:pt idx="1">
                  <c:v>1.72292473319884</c:v>
                </c:pt>
                <c:pt idx="2">
                  <c:v>1.8412019282868399</c:v>
                </c:pt>
                <c:pt idx="3">
                  <c:v>1.8481945537590301</c:v>
                </c:pt>
                <c:pt idx="4">
                  <c:v>1.9379692961464099</c:v>
                </c:pt>
                <c:pt idx="5">
                  <c:v>2.2864645993502402</c:v>
                </c:pt>
                <c:pt idx="6">
                  <c:v>3.1822404489178502</c:v>
                </c:pt>
                <c:pt idx="7">
                  <c:v>3.61320748732882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CE-4E4F-8C0A-4AAF6C2732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775913503"/>
        <c:axId val="1817018319"/>
      </c:barChart>
      <c:catAx>
        <c:axId val="177591350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018319"/>
        <c:crosses val="autoZero"/>
        <c:auto val="1"/>
        <c:lblAlgn val="ctr"/>
        <c:lblOffset val="100"/>
        <c:noMultiLvlLbl val="0"/>
      </c:catAx>
      <c:valAx>
        <c:axId val="1817018319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0" i="0" u="none" strike="noStrike" baseline="0">
                    <a:effectLst/>
                  </a:rPr>
                  <a:t>-log</a:t>
                </a:r>
                <a:r>
                  <a:rPr lang="en-US" sz="1200" b="0" i="0" u="none" strike="noStrike" baseline="-25000">
                    <a:effectLst/>
                  </a:rPr>
                  <a:t>10</a:t>
                </a:r>
                <a:r>
                  <a:rPr lang="en-US" sz="1200" b="0" i="0" u="none" strike="noStrike" baseline="0">
                    <a:effectLst/>
                  </a:rPr>
                  <a:t> (</a:t>
                </a:r>
                <a:r>
                  <a:rPr lang="en-US"/>
                  <a:t>adjusted p-value)</a:t>
                </a:r>
                <a:endParaRPr lang="en-GB"/>
              </a:p>
            </c:rich>
          </c:tx>
          <c:layout>
            <c:manualLayout>
              <c:xMode val="edge"/>
              <c:yMode val="edge"/>
              <c:x val="0.64811586871782667"/>
              <c:y val="0.8977078119443013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59135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1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i="1"/>
              <a:t>Celullar Componen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1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56126076616137854"/>
          <c:y val="0.16708333333333336"/>
          <c:w val="0.41904319944553192"/>
          <c:h val="0.58561679790026244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EE9CEE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605-421B-B6B0-6FE9C1ED8700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605-421B-B6B0-6FE9C1ED8700}"/>
              </c:ext>
            </c:extLst>
          </c:dPt>
          <c:dPt>
            <c:idx val="4"/>
            <c:invertIfNegative val="0"/>
            <c:bubble3D val="0"/>
            <c:spPr>
              <a:solidFill>
                <a:srgbClr val="B2DE8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605-421B-B6B0-6FE9C1ED8700}"/>
              </c:ext>
            </c:extLst>
          </c:dPt>
          <c:dPt>
            <c:idx val="5"/>
            <c:invertIfNegative val="0"/>
            <c:bubble3D val="0"/>
            <c:spPr>
              <a:solidFill>
                <a:srgbClr val="B2DE8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605-421B-B6B0-6FE9C1ED8700}"/>
              </c:ext>
            </c:extLst>
          </c:dPt>
          <c:dPt>
            <c:idx val="6"/>
            <c:invertIfNegative val="0"/>
            <c:bubble3D val="0"/>
            <c:spPr>
              <a:solidFill>
                <a:srgbClr val="B2DE8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C605-421B-B6B0-6FE9C1ED8700}"/>
              </c:ext>
            </c:extLst>
          </c:dPt>
          <c:dPt>
            <c:idx val="7"/>
            <c:invertIfNegative val="0"/>
            <c:bubble3D val="0"/>
            <c:spPr>
              <a:solidFill>
                <a:srgbClr val="B2DE8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C605-421B-B6B0-6FE9C1ED8700}"/>
              </c:ext>
            </c:extLst>
          </c:dPt>
          <c:cat>
            <c:strRef>
              <c:f>Figures!$B$16:$B$23</c:f>
              <c:strCache>
                <c:ptCount val="8"/>
                <c:pt idx="1">
                  <c:v>Intrinsic component of plasma membrane</c:v>
                </c:pt>
                <c:pt idx="2">
                  <c:v>Extracellular region</c:v>
                </c:pt>
                <c:pt idx="4">
                  <c:v>Extracellular matrix</c:v>
                </c:pt>
                <c:pt idx="5">
                  <c:v>Fibrillar collagen trimer</c:v>
                </c:pt>
                <c:pt idx="6">
                  <c:v>Banded collagen fibril</c:v>
                </c:pt>
                <c:pt idx="7">
                  <c:v>Collagen-containing extracellular matrix</c:v>
                </c:pt>
              </c:strCache>
            </c:strRef>
          </c:cat>
          <c:val>
            <c:numRef>
              <c:f>Figures!$C$16:$C$23</c:f>
              <c:numCache>
                <c:formatCode>General</c:formatCode>
                <c:ptCount val="8"/>
                <c:pt idx="1">
                  <c:v>1.3443814700391401</c:v>
                </c:pt>
                <c:pt idx="2">
                  <c:v>2.11474772991546</c:v>
                </c:pt>
                <c:pt idx="4">
                  <c:v>1.69744172581898</c:v>
                </c:pt>
                <c:pt idx="5">
                  <c:v>2.2030879052093399</c:v>
                </c:pt>
                <c:pt idx="6">
                  <c:v>2.2030879052093399</c:v>
                </c:pt>
                <c:pt idx="7">
                  <c:v>2.366101254671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C605-421B-B6B0-6FE9C1ED87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746017199"/>
        <c:axId val="1817005007"/>
      </c:barChart>
      <c:catAx>
        <c:axId val="1746017199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7005007"/>
        <c:crosses val="autoZero"/>
        <c:auto val="1"/>
        <c:lblAlgn val="ctr"/>
        <c:lblOffset val="100"/>
        <c:noMultiLvlLbl val="0"/>
      </c:catAx>
      <c:valAx>
        <c:axId val="1817005007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0" i="0" u="none" strike="noStrike" baseline="0">
                    <a:effectLst/>
                  </a:rPr>
                  <a:t>-log</a:t>
                </a:r>
                <a:r>
                  <a:rPr lang="en-US" sz="1200" b="0" i="0" u="none" strike="noStrike" baseline="-25000">
                    <a:effectLst/>
                  </a:rPr>
                  <a:t>10</a:t>
                </a:r>
                <a:r>
                  <a:rPr lang="en-US" sz="1200" b="0" i="0" u="none" strike="noStrike" baseline="0">
                    <a:effectLst/>
                  </a:rPr>
                  <a:t> (</a:t>
                </a:r>
                <a:r>
                  <a:rPr lang="en-US"/>
                  <a:t>adjusted p-value)</a:t>
                </a:r>
                <a:endParaRPr lang="en-GB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60171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6128</cdr:x>
      <cdr:y>0.37315</cdr:y>
    </cdr:from>
    <cdr:to>
      <cdr:x>0.17531</cdr:x>
      <cdr:y>0.68662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8E241884-25FF-4FEC-9044-938098A636FC}"/>
            </a:ext>
          </a:extLst>
        </cdr:cNvPr>
        <cdr:cNvSpPr txBox="1"/>
      </cdr:nvSpPr>
      <cdr:spPr>
        <a:xfrm xmlns:a="http://schemas.openxmlformats.org/drawingml/2006/main">
          <a:off x="411892" y="1192955"/>
          <a:ext cx="766450" cy="10021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200" b="1"/>
            <a:t>MMS</a:t>
          </a:r>
          <a:endParaRPr lang="en-GB" sz="1100" b="1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459</cdr:x>
      <cdr:y>0.23167</cdr:y>
    </cdr:from>
    <cdr:to>
      <cdr:x>0.21829</cdr:x>
      <cdr:y>0.5380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FF38372F-A6ED-44D1-AF8D-B24946A31EE7}"/>
            </a:ext>
          </a:extLst>
        </cdr:cNvPr>
        <cdr:cNvSpPr txBox="1"/>
      </cdr:nvSpPr>
      <cdr:spPr>
        <a:xfrm xmlns:a="http://schemas.openxmlformats.org/drawingml/2006/main">
          <a:off x="308654" y="664146"/>
          <a:ext cx="1159339" cy="87820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200" b="1"/>
            <a:t>MMS</a:t>
          </a:r>
        </a:p>
      </cdr:txBody>
    </cdr:sp>
  </cdr:relSizeAnchor>
  <cdr:relSizeAnchor xmlns:cdr="http://schemas.openxmlformats.org/drawingml/2006/chartDrawing">
    <cdr:from>
      <cdr:x>0.0151</cdr:x>
      <cdr:y>0.62583</cdr:y>
    </cdr:from>
    <cdr:to>
      <cdr:x>0.18749</cdr:x>
      <cdr:y>0.93217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82ED1406-6238-4123-BC73-59F9AD26194C}"/>
            </a:ext>
          </a:extLst>
        </cdr:cNvPr>
        <cdr:cNvSpPr txBox="1"/>
      </cdr:nvSpPr>
      <cdr:spPr>
        <a:xfrm xmlns:a="http://schemas.openxmlformats.org/drawingml/2006/main">
          <a:off x="101515" y="1794092"/>
          <a:ext cx="1159338" cy="8782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200" b="1"/>
            <a:t>LPS+MMS</a:t>
          </a:r>
        </a:p>
      </cdr:txBody>
    </cdr:sp>
  </cdr:relSizeAnchor>
  <cdr:relSizeAnchor xmlns:cdr="http://schemas.openxmlformats.org/drawingml/2006/chartDrawing">
    <cdr:from>
      <cdr:x>0.08438</cdr:x>
      <cdr:y>0.53629</cdr:y>
    </cdr:from>
    <cdr:to>
      <cdr:x>0.53633</cdr:x>
      <cdr:y>0.54303</cdr:y>
    </cdr:to>
    <cdr:cxnSp macro="">
      <cdr:nvCxnSpPr>
        <cdr:cNvPr id="5" name="Straight Connector 4">
          <a:extLst xmlns:a="http://schemas.openxmlformats.org/drawingml/2006/main">
            <a:ext uri="{FF2B5EF4-FFF2-40B4-BE49-F238E27FC236}">
              <a16:creationId xmlns:a16="http://schemas.microsoft.com/office/drawing/2014/main" id="{EC512324-68A4-4D06-9D1C-9B67BAF7B8B9}"/>
            </a:ext>
          </a:extLst>
        </cdr:cNvPr>
        <cdr:cNvCxnSpPr/>
      </cdr:nvCxnSpPr>
      <cdr:spPr>
        <a:xfrm xmlns:a="http://schemas.openxmlformats.org/drawingml/2006/main" flipH="1" flipV="1">
          <a:off x="567481" y="1537412"/>
          <a:ext cx="3039373" cy="19321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bg2">
              <a:lumMod val="90000"/>
            </a:schemeClr>
          </a:solidFill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FAA7F-DA34-4B59-A2CA-6E3C03686850}" type="datetimeFigureOut">
              <a:rPr lang="en-GB" smtClean="0"/>
              <a:t>14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906C-975D-454A-949B-E2B90D3032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9112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FAA7F-DA34-4B59-A2CA-6E3C03686850}" type="datetimeFigureOut">
              <a:rPr lang="en-GB" smtClean="0"/>
              <a:t>14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906C-975D-454A-949B-E2B90D3032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509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FAA7F-DA34-4B59-A2CA-6E3C03686850}" type="datetimeFigureOut">
              <a:rPr lang="en-GB" smtClean="0"/>
              <a:t>14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906C-975D-454A-949B-E2B90D3032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3239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FAA7F-DA34-4B59-A2CA-6E3C03686850}" type="datetimeFigureOut">
              <a:rPr lang="en-GB" smtClean="0"/>
              <a:t>14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906C-975D-454A-949B-E2B90D3032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6568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FAA7F-DA34-4B59-A2CA-6E3C03686850}" type="datetimeFigureOut">
              <a:rPr lang="en-GB" smtClean="0"/>
              <a:t>14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906C-975D-454A-949B-E2B90D3032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2376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FAA7F-DA34-4B59-A2CA-6E3C03686850}" type="datetimeFigureOut">
              <a:rPr lang="en-GB" smtClean="0"/>
              <a:t>14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906C-975D-454A-949B-E2B90D3032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236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FAA7F-DA34-4B59-A2CA-6E3C03686850}" type="datetimeFigureOut">
              <a:rPr lang="en-GB" smtClean="0"/>
              <a:t>14/1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906C-975D-454A-949B-E2B90D3032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6505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FAA7F-DA34-4B59-A2CA-6E3C03686850}" type="datetimeFigureOut">
              <a:rPr lang="en-GB" smtClean="0"/>
              <a:t>14/1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906C-975D-454A-949B-E2B90D3032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4917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FAA7F-DA34-4B59-A2CA-6E3C03686850}" type="datetimeFigureOut">
              <a:rPr lang="en-GB" smtClean="0"/>
              <a:t>14/1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906C-975D-454A-949B-E2B90D3032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27212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FAA7F-DA34-4B59-A2CA-6E3C03686850}" type="datetimeFigureOut">
              <a:rPr lang="en-GB" smtClean="0"/>
              <a:t>14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906C-975D-454A-949B-E2B90D3032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03680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FAA7F-DA34-4B59-A2CA-6E3C03686850}" type="datetimeFigureOut">
              <a:rPr lang="en-GB" smtClean="0"/>
              <a:t>14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24906C-975D-454A-949B-E2B90D3032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0921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7FAA7F-DA34-4B59-A2CA-6E3C03686850}" type="datetimeFigureOut">
              <a:rPr lang="en-GB" smtClean="0"/>
              <a:t>14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24906C-975D-454A-949B-E2B90D3032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2266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4E7F9333-BA9B-4498-8D43-79BB456155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4808880"/>
              </p:ext>
            </p:extLst>
          </p:nvPr>
        </p:nvGraphicFramePr>
        <p:xfrm>
          <a:off x="61571" y="3686666"/>
          <a:ext cx="6744054" cy="31026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FEC57C7F-47DC-4DDC-8BDB-0C89E25349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8926254"/>
              </p:ext>
            </p:extLst>
          </p:nvPr>
        </p:nvGraphicFramePr>
        <p:xfrm>
          <a:off x="115996" y="6914241"/>
          <a:ext cx="6747724" cy="27828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5" name="Picture 14">
            <a:extLst>
              <a:ext uri="{FF2B5EF4-FFF2-40B4-BE49-F238E27FC236}">
                <a16:creationId xmlns:a16="http://schemas.microsoft.com/office/drawing/2014/main" id="{9522E654-380D-4050-AA17-2AC0CA040B7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2397" y="1172973"/>
            <a:ext cx="5762244" cy="202082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B7AA626-45E2-49DC-A4A7-D9605E6D7DC1}"/>
              </a:ext>
            </a:extLst>
          </p:cNvPr>
          <p:cNvSpPr txBox="1"/>
          <p:nvPr/>
        </p:nvSpPr>
        <p:spPr>
          <a:xfrm>
            <a:off x="393539" y="116732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BFB854A-3BC0-4853-95EC-D76DA95C17C7}"/>
              </a:ext>
            </a:extLst>
          </p:cNvPr>
          <p:cNvSpPr txBox="1"/>
          <p:nvPr/>
        </p:nvSpPr>
        <p:spPr>
          <a:xfrm>
            <a:off x="393539" y="335356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AF3C0C0-39CB-4FA6-8189-7E44B33FD600}"/>
              </a:ext>
            </a:extLst>
          </p:cNvPr>
          <p:cNvSpPr txBox="1"/>
          <p:nvPr/>
        </p:nvSpPr>
        <p:spPr>
          <a:xfrm>
            <a:off x="399836" y="641996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029710E-E0AC-4C4F-AC17-4FFBA7D1AB35}"/>
              </a:ext>
            </a:extLst>
          </p:cNvPr>
          <p:cNvSpPr txBox="1"/>
          <p:nvPr/>
        </p:nvSpPr>
        <p:spPr>
          <a:xfrm>
            <a:off x="150471" y="451412"/>
            <a:ext cx="2251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42415186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</TotalTime>
  <Words>27</Words>
  <Application>Microsoft Macintosh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TZGERALD Eamon</dc:creator>
  <cp:lastModifiedBy>DRAKE Amanda</cp:lastModifiedBy>
  <cp:revision>12</cp:revision>
  <dcterms:created xsi:type="dcterms:W3CDTF">2020-08-21T10:02:41Z</dcterms:created>
  <dcterms:modified xsi:type="dcterms:W3CDTF">2020-12-14T13:58:28Z</dcterms:modified>
</cp:coreProperties>
</file>